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3" r:id="rId2"/>
    <p:sldId id="305" r:id="rId3"/>
    <p:sldId id="306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3">
            <a:extLst>
              <a:ext uri="{FF2B5EF4-FFF2-40B4-BE49-F238E27FC236}">
                <a16:creationId xmlns:a16="http://schemas.microsoft.com/office/drawing/2014/main" id="{56E5C740-2274-4598-B76B-32D6C23B0E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1472279"/>
              </p:ext>
            </p:extLst>
          </p:nvPr>
        </p:nvGraphicFramePr>
        <p:xfrm>
          <a:off x="134633" y="1124744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7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18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0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8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.9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4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en-US" altLang="ja-JP" sz="1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40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3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8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5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4" name="タイトル 1">
            <a:extLst>
              <a:ext uri="{FF2B5EF4-FFF2-40B4-BE49-F238E27FC236}">
                <a16:creationId xmlns:a16="http://schemas.microsoft.com/office/drawing/2014/main" id="{71457FF5-293C-4101-936E-47859051F1D6}"/>
              </a:ext>
            </a:extLst>
          </p:cNvPr>
          <p:cNvSpPr txBox="1">
            <a:spLocks/>
          </p:cNvSpPr>
          <p:nvPr/>
        </p:nvSpPr>
        <p:spPr>
          <a:xfrm>
            <a:off x="134632" y="226325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4 Table: </a:t>
            </a:r>
            <a:r>
              <a:rPr lang="en-US" altLang="ja-JP" sz="20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velet analysis for preschoolers.</a:t>
            </a:r>
            <a:br>
              <a:rPr lang="ja-JP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The encoding period for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m</a:t>
            </a:r>
            <a:r>
              <a:rPr lang="en-US" altLang="ja-JP" sz="2000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θ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82E882A-4D0B-4B53-856E-61F3B61053E3}"/>
              </a:ext>
            </a:extLst>
          </p:cNvPr>
          <p:cNvSpPr txBox="1"/>
          <p:nvPr/>
        </p:nvSpPr>
        <p:spPr>
          <a:xfrm>
            <a:off x="4572000" y="6521460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3973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401FD07C-8D10-4AD6-80E6-B87D0AFE175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47290335"/>
                  </p:ext>
                </p:extLst>
              </p:nvPr>
            </p:nvGraphicFramePr>
            <p:xfrm>
              <a:off x="161760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3.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1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8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8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7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3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1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15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9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401FD07C-8D10-4AD6-80E6-B87D0AFE175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47290335"/>
                  </p:ext>
                </p:extLst>
              </p:nvPr>
            </p:nvGraphicFramePr>
            <p:xfrm>
              <a:off x="161760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380" t="-671" r="-1408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3.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1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8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8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7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3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1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15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9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5" name="タイトル 1">
            <a:extLst>
              <a:ext uri="{FF2B5EF4-FFF2-40B4-BE49-F238E27FC236}">
                <a16:creationId xmlns:a16="http://schemas.microsoft.com/office/drawing/2014/main" id="{1D864F07-CF78-455D-86F6-DDE2AD91BF30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The encoding period for Pm</a:t>
            </a:r>
            <a:r>
              <a:rPr lang="en-US" altLang="ja-JP" sz="20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α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Multiple comparisons of Face conditions.</a:t>
            </a:r>
            <a:r>
              <a:rPr lang="ja-JP" altLang="en-US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001E0CD-7C24-45E9-8541-F1CA582DB7E8}"/>
              </a:ext>
            </a:extLst>
          </p:cNvPr>
          <p:cNvSpPr txBox="1"/>
          <p:nvPr/>
        </p:nvSpPr>
        <p:spPr>
          <a:xfrm>
            <a:off x="4572000" y="4283804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52499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EB075C7D-4CA9-4C1F-A7F1-CE323AE50D2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02757076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3.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5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8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5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52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52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18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7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EB075C7D-4CA9-4C1F-A7F1-CE323AE50D2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02757076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1342" r="-1761" b="-273154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3.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5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8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5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52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52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18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7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6" name="タイトル 1">
            <a:extLst>
              <a:ext uri="{FF2B5EF4-FFF2-40B4-BE49-F238E27FC236}">
                <a16:creationId xmlns:a16="http://schemas.microsoft.com/office/drawing/2014/main" id="{8BABC9B7-9384-4EB7-9AB8-661260E17E83}"/>
              </a:ext>
            </a:extLst>
          </p:cNvPr>
          <p:cNvSpPr txBox="1">
            <a:spLocks/>
          </p:cNvSpPr>
          <p:nvPr/>
        </p:nvSpPr>
        <p:spPr>
          <a:xfrm>
            <a:off x="134632" y="226325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 The latter retention period for Pm</a:t>
            </a:r>
            <a:r>
              <a:rPr lang="en-US" altLang="ja-JP" sz="20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α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Multiple comparisons between Face conditions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2241EA2-6BF7-4579-9F12-E299F3F05270}"/>
              </a:ext>
            </a:extLst>
          </p:cNvPr>
          <p:cNvSpPr txBox="1"/>
          <p:nvPr/>
        </p:nvSpPr>
        <p:spPr>
          <a:xfrm>
            <a:off x="4572000" y="457183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7375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1</TotalTime>
  <Words>273</Words>
  <Application>Microsoft Office PowerPoint</Application>
  <PresentationFormat>画面に合わせる (4:3)</PresentationFormat>
  <Paragraphs>7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71</cp:revision>
  <dcterms:created xsi:type="dcterms:W3CDTF">2019-08-15T18:36:33Z</dcterms:created>
  <dcterms:modified xsi:type="dcterms:W3CDTF">2022-04-02T17:03:56Z</dcterms:modified>
</cp:coreProperties>
</file>